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A55129-3059-437A-B759-95645DAF649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CFD85B-9C52-406A-B1B9-BAC9E77E543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8B74F3-E9F7-46D8-BBEF-C5EC0C61FF3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D0DC19-9CDB-4254-A619-0FEA0A7DE98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5F93D6-DA9B-4609-86B9-3A80433B87D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3F7003-06FF-4489-BD5C-3BDF50DECE2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DD1A92-8BB9-45B9-96A3-2AB02AE958C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443257-616E-4CA3-ABED-F50D013B62B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28B70D-3514-41D4-A2B9-CE6B798CE9A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C6F9B1-B013-4DEF-9B66-1DDAC5958E3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45C6FB-37E2-4C9C-B577-3C03442D547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A546C5-FFB9-4729-B9CE-95B1802EADA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BD834B4-1BDC-4C4E-85BD-74E41F626101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"/>
          <p:cNvPicPr/>
          <p:nvPr/>
        </p:nvPicPr>
        <p:blipFill>
          <a:blip r:embed="rId1"/>
          <a:stretch/>
        </p:blipFill>
        <p:spPr>
          <a:xfrm>
            <a:off x="2662200" y="3719520"/>
            <a:ext cx="947880" cy="112392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2" descr=""/>
          <p:cNvPicPr/>
          <p:nvPr/>
        </p:nvPicPr>
        <p:blipFill>
          <a:blip r:embed="rId2"/>
          <a:stretch/>
        </p:blipFill>
        <p:spPr>
          <a:xfrm>
            <a:off x="1733400" y="3719520"/>
            <a:ext cx="947880" cy="1123920"/>
          </a:xfrm>
          <a:prstGeom prst="rect">
            <a:avLst/>
          </a:prstGeom>
          <a:ln w="0">
            <a:noFill/>
          </a:ln>
        </p:spPr>
      </p:pic>
      <p:sp>
        <p:nvSpPr>
          <p:cNvPr id="43" name="TextBox 1"/>
          <p:cNvSpPr/>
          <p:nvPr/>
        </p:nvSpPr>
        <p:spPr>
          <a:xfrm>
            <a:off x="4946760" y="8821800"/>
            <a:ext cx="1780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Vautier et al Supplemental Figure 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4" name="Group 94"/>
          <p:cNvGrpSpPr/>
          <p:nvPr/>
        </p:nvGrpSpPr>
        <p:grpSpPr>
          <a:xfrm>
            <a:off x="1268280" y="1116000"/>
            <a:ext cx="4314960" cy="2327760"/>
            <a:chOff x="1268280" y="1116000"/>
            <a:chExt cx="4314960" cy="2327760"/>
          </a:xfrm>
        </p:grpSpPr>
        <p:pic>
          <p:nvPicPr>
            <p:cNvPr id="45" name="Picture 19" descr=""/>
            <p:cNvPicPr/>
            <p:nvPr/>
          </p:nvPicPr>
          <p:blipFill>
            <a:blip r:embed="rId3"/>
            <a:stretch/>
          </p:blipFill>
          <p:spPr>
            <a:xfrm>
              <a:off x="1755360" y="2211840"/>
              <a:ext cx="3827880" cy="1132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6" name="TextBox 29"/>
            <p:cNvSpPr/>
            <p:nvPr/>
          </p:nvSpPr>
          <p:spPr>
            <a:xfrm rot="16200000">
              <a:off x="834480" y="2211120"/>
              <a:ext cx="1209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cytokine pg/mg protei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47" name="Group 30"/>
            <p:cNvGrpSpPr/>
            <p:nvPr/>
          </p:nvGrpSpPr>
          <p:grpSpPr>
            <a:xfrm>
              <a:off x="1493640" y="1370160"/>
              <a:ext cx="407520" cy="932400"/>
              <a:chOff x="1493640" y="1370160"/>
              <a:chExt cx="407520" cy="932400"/>
            </a:xfrm>
          </p:grpSpPr>
          <p:sp>
            <p:nvSpPr>
              <p:cNvPr id="48" name="TextBox 31"/>
              <p:cNvSpPr/>
              <p:nvPr/>
            </p:nvSpPr>
            <p:spPr>
              <a:xfrm>
                <a:off x="1493640" y="2086920"/>
                <a:ext cx="406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&lt;10</a:t>
                </a:r>
                <a:r>
                  <a:rPr b="0" lang="en-GB" sz="8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-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9" name="TextBox 6"/>
              <p:cNvSpPr/>
              <p:nvPr/>
            </p:nvSpPr>
            <p:spPr>
              <a:xfrm>
                <a:off x="1574280" y="1800000"/>
                <a:ext cx="326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0" lang="en-GB" sz="8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" name="TextBox 7"/>
              <p:cNvSpPr/>
              <p:nvPr/>
            </p:nvSpPr>
            <p:spPr>
              <a:xfrm>
                <a:off x="1574280" y="1656720"/>
                <a:ext cx="326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0" lang="en-GB" sz="8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" name="TextBox 34"/>
              <p:cNvSpPr/>
              <p:nvPr/>
            </p:nvSpPr>
            <p:spPr>
              <a:xfrm>
                <a:off x="1574280" y="1513440"/>
                <a:ext cx="326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0" lang="en-GB" sz="8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3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" name="TextBox 35"/>
              <p:cNvSpPr/>
              <p:nvPr/>
            </p:nvSpPr>
            <p:spPr>
              <a:xfrm>
                <a:off x="1574280" y="1943640"/>
                <a:ext cx="326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0" lang="en-GB" sz="8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" name="TextBox 36"/>
              <p:cNvSpPr/>
              <p:nvPr/>
            </p:nvSpPr>
            <p:spPr>
              <a:xfrm>
                <a:off x="1574280" y="1370160"/>
                <a:ext cx="326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0" lang="en-GB" sz="8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54" name="TextBox 37"/>
            <p:cNvSpPr/>
            <p:nvPr/>
          </p:nvSpPr>
          <p:spPr>
            <a:xfrm>
              <a:off x="1897200" y="1377360"/>
              <a:ext cx="651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aecum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TextBox 38"/>
            <p:cNvSpPr/>
            <p:nvPr/>
          </p:nvSpPr>
          <p:spPr>
            <a:xfrm>
              <a:off x="1893240" y="3228120"/>
              <a:ext cx="41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L-1</a:t>
              </a:r>
              <a:r>
                <a:rPr b="0" lang="el-G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α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TextBox 39"/>
            <p:cNvSpPr/>
            <p:nvPr/>
          </p:nvSpPr>
          <p:spPr>
            <a:xfrm>
              <a:off x="2283840" y="3228120"/>
              <a:ext cx="41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L-1</a:t>
              </a:r>
              <a:r>
                <a:rPr b="0" lang="el-G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β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TextBox 40"/>
            <p:cNvSpPr/>
            <p:nvPr/>
          </p:nvSpPr>
          <p:spPr>
            <a:xfrm>
              <a:off x="2720160" y="3228120"/>
              <a:ext cx="356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L-6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TextBox 41"/>
            <p:cNvSpPr/>
            <p:nvPr/>
          </p:nvSpPr>
          <p:spPr>
            <a:xfrm>
              <a:off x="3091680" y="3228120"/>
              <a:ext cx="412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L-17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TextBox 42"/>
            <p:cNvSpPr/>
            <p:nvPr/>
          </p:nvSpPr>
          <p:spPr>
            <a:xfrm>
              <a:off x="3454560" y="3228120"/>
              <a:ext cx="497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G-CSF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TextBox 43"/>
            <p:cNvSpPr/>
            <p:nvPr/>
          </p:nvSpPr>
          <p:spPr>
            <a:xfrm>
              <a:off x="3902040" y="3228120"/>
              <a:ext cx="397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FN</a:t>
              </a:r>
              <a:r>
                <a:rPr b="0" lang="el-G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γ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TextBox 44"/>
            <p:cNvSpPr/>
            <p:nvPr/>
          </p:nvSpPr>
          <p:spPr>
            <a:xfrm>
              <a:off x="4342320" y="3228120"/>
              <a:ext cx="32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K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TextBox 45"/>
            <p:cNvSpPr/>
            <p:nvPr/>
          </p:nvSpPr>
          <p:spPr>
            <a:xfrm>
              <a:off x="4645800" y="3228120"/>
              <a:ext cx="513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MIP-1</a:t>
              </a:r>
              <a:r>
                <a:rPr b="0" lang="el-G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β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TextBox 46"/>
            <p:cNvSpPr/>
            <p:nvPr/>
          </p:nvSpPr>
          <p:spPr>
            <a:xfrm>
              <a:off x="5117040" y="3228120"/>
              <a:ext cx="378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TNF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64" name="Group 47"/>
            <p:cNvGrpSpPr/>
            <p:nvPr/>
          </p:nvGrpSpPr>
          <p:grpSpPr>
            <a:xfrm>
              <a:off x="1493640" y="2340720"/>
              <a:ext cx="407520" cy="932400"/>
              <a:chOff x="1493640" y="2340720"/>
              <a:chExt cx="407520" cy="932400"/>
            </a:xfrm>
          </p:grpSpPr>
          <p:sp>
            <p:nvSpPr>
              <p:cNvPr id="65" name="TextBox 48"/>
              <p:cNvSpPr/>
              <p:nvPr/>
            </p:nvSpPr>
            <p:spPr>
              <a:xfrm>
                <a:off x="1493640" y="3057480"/>
                <a:ext cx="406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&lt;10</a:t>
                </a:r>
                <a:r>
                  <a:rPr b="0" lang="en-GB" sz="8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-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" name="TextBox 6"/>
              <p:cNvSpPr/>
              <p:nvPr/>
            </p:nvSpPr>
            <p:spPr>
              <a:xfrm>
                <a:off x="1574280" y="2770560"/>
                <a:ext cx="326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0" lang="en-GB" sz="8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" name="TextBox 7"/>
              <p:cNvSpPr/>
              <p:nvPr/>
            </p:nvSpPr>
            <p:spPr>
              <a:xfrm>
                <a:off x="1574280" y="2627280"/>
                <a:ext cx="326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0" lang="en-GB" sz="8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" name="TextBox 51"/>
              <p:cNvSpPr/>
              <p:nvPr/>
            </p:nvSpPr>
            <p:spPr>
              <a:xfrm>
                <a:off x="1574280" y="2484000"/>
                <a:ext cx="326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0" lang="en-GB" sz="8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3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" name="TextBox 52"/>
              <p:cNvSpPr/>
              <p:nvPr/>
            </p:nvSpPr>
            <p:spPr>
              <a:xfrm>
                <a:off x="1574280" y="2914200"/>
                <a:ext cx="326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0" lang="en-GB" sz="8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" name="TextBox 53"/>
              <p:cNvSpPr/>
              <p:nvPr/>
            </p:nvSpPr>
            <p:spPr>
              <a:xfrm>
                <a:off x="1574280" y="2340720"/>
                <a:ext cx="326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0" lang="en-GB" sz="8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71" name="TextBox 54"/>
            <p:cNvSpPr/>
            <p:nvPr/>
          </p:nvSpPr>
          <p:spPr>
            <a:xfrm>
              <a:off x="1905480" y="2347920"/>
              <a:ext cx="1038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large intestin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72" name="Picture 18" descr=""/>
            <p:cNvPicPr/>
            <p:nvPr/>
          </p:nvPicPr>
          <p:blipFill>
            <a:blip r:embed="rId4"/>
            <a:stretch/>
          </p:blipFill>
          <p:spPr>
            <a:xfrm>
              <a:off x="1755360" y="1231920"/>
              <a:ext cx="3827880" cy="1132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3" name="TextBox 93"/>
            <p:cNvSpPr/>
            <p:nvPr/>
          </p:nvSpPr>
          <p:spPr>
            <a:xfrm>
              <a:off x="1268280" y="1116000"/>
              <a:ext cx="375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 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4" name="TextBox 96"/>
          <p:cNvSpPr/>
          <p:nvPr/>
        </p:nvSpPr>
        <p:spPr>
          <a:xfrm>
            <a:off x="1271520" y="3659040"/>
            <a:ext cx="375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B 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99"/>
          <p:cNvSpPr/>
          <p:nvPr/>
        </p:nvSpPr>
        <p:spPr>
          <a:xfrm rot="16200000">
            <a:off x="1185840" y="4213800"/>
            <a:ext cx="720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CFU/g stool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Box 100"/>
          <p:cNvSpPr/>
          <p:nvPr/>
        </p:nvSpPr>
        <p:spPr>
          <a:xfrm>
            <a:off x="1569240" y="4002120"/>
            <a:ext cx="326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r>
              <a:rPr b="0" lang="en-GB" sz="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7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Box 101"/>
          <p:cNvSpPr/>
          <p:nvPr/>
        </p:nvSpPr>
        <p:spPr>
          <a:xfrm>
            <a:off x="1569240" y="4146480"/>
            <a:ext cx="326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r>
              <a:rPr b="0" lang="en-GB" sz="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Box 102"/>
          <p:cNvSpPr/>
          <p:nvPr/>
        </p:nvSpPr>
        <p:spPr>
          <a:xfrm>
            <a:off x="1569240" y="4433760"/>
            <a:ext cx="326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r>
              <a:rPr b="0" lang="en-GB" sz="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Box 103"/>
          <p:cNvSpPr/>
          <p:nvPr/>
        </p:nvSpPr>
        <p:spPr>
          <a:xfrm>
            <a:off x="1569240" y="4290840"/>
            <a:ext cx="326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r>
              <a:rPr b="0" lang="en-GB" sz="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Box 104"/>
          <p:cNvSpPr/>
          <p:nvPr/>
        </p:nvSpPr>
        <p:spPr>
          <a:xfrm>
            <a:off x="1569240" y="3857760"/>
            <a:ext cx="326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r>
              <a:rPr b="0" lang="en-GB" sz="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8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TextBox 105"/>
          <p:cNvSpPr/>
          <p:nvPr/>
        </p:nvSpPr>
        <p:spPr>
          <a:xfrm>
            <a:off x="2021040" y="470376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1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TextBox 106"/>
          <p:cNvSpPr/>
          <p:nvPr/>
        </p:nvSpPr>
        <p:spPr>
          <a:xfrm>
            <a:off x="2230560" y="470376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2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TextBox 107"/>
          <p:cNvSpPr/>
          <p:nvPr/>
        </p:nvSpPr>
        <p:spPr>
          <a:xfrm>
            <a:off x="2438640" y="470376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2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TextBox 108"/>
          <p:cNvSpPr/>
          <p:nvPr/>
        </p:nvSpPr>
        <p:spPr>
          <a:xfrm>
            <a:off x="1805040" y="470376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TextBox 109"/>
          <p:cNvSpPr/>
          <p:nvPr/>
        </p:nvSpPr>
        <p:spPr>
          <a:xfrm>
            <a:off x="1990800" y="4816440"/>
            <a:ext cx="526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time (d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Straight Connector 110"/>
          <p:cNvSpPr/>
          <p:nvPr/>
        </p:nvSpPr>
        <p:spPr>
          <a:xfrm flipV="1">
            <a:off x="2082960" y="3941640"/>
            <a:ext cx="0" cy="765360"/>
          </a:xfrm>
          <a:prstGeom prst="line">
            <a:avLst/>
          </a:prstGeom>
          <a:ln w="64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TextBox 111"/>
          <p:cNvSpPr/>
          <p:nvPr/>
        </p:nvSpPr>
        <p:spPr>
          <a:xfrm>
            <a:off x="1919880" y="3755880"/>
            <a:ext cx="578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wild type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TextBox 112"/>
          <p:cNvSpPr/>
          <p:nvPr/>
        </p:nvSpPr>
        <p:spPr>
          <a:xfrm>
            <a:off x="2949480" y="470376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1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TextBox 113"/>
          <p:cNvSpPr/>
          <p:nvPr/>
        </p:nvSpPr>
        <p:spPr>
          <a:xfrm>
            <a:off x="3159360" y="470376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2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TextBox 114"/>
          <p:cNvSpPr/>
          <p:nvPr/>
        </p:nvSpPr>
        <p:spPr>
          <a:xfrm>
            <a:off x="3367080" y="470376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2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TextBox 115"/>
          <p:cNvSpPr/>
          <p:nvPr/>
        </p:nvSpPr>
        <p:spPr>
          <a:xfrm>
            <a:off x="2733840" y="470376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TextBox 116"/>
          <p:cNvSpPr/>
          <p:nvPr/>
        </p:nvSpPr>
        <p:spPr>
          <a:xfrm>
            <a:off x="2919600" y="4816440"/>
            <a:ext cx="526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time (d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Straight Connector 117"/>
          <p:cNvSpPr/>
          <p:nvPr/>
        </p:nvSpPr>
        <p:spPr>
          <a:xfrm flipV="1">
            <a:off x="3011400" y="3941640"/>
            <a:ext cx="0" cy="765360"/>
          </a:xfrm>
          <a:prstGeom prst="line">
            <a:avLst/>
          </a:prstGeom>
          <a:ln w="64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TextBox 118"/>
          <p:cNvSpPr/>
          <p:nvPr/>
        </p:nvSpPr>
        <p:spPr>
          <a:xfrm>
            <a:off x="2853000" y="3755880"/>
            <a:ext cx="577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IL17RA</a:t>
            </a:r>
            <a:r>
              <a:rPr b="0" lang="en-GB" sz="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-/-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TextBox 119"/>
          <p:cNvSpPr/>
          <p:nvPr/>
        </p:nvSpPr>
        <p:spPr>
          <a:xfrm>
            <a:off x="1569240" y="4578480"/>
            <a:ext cx="326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r>
              <a:rPr b="0" lang="en-GB" sz="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96" name="Group 56"/>
          <p:cNvGrpSpPr/>
          <p:nvPr/>
        </p:nvGrpSpPr>
        <p:grpSpPr>
          <a:xfrm>
            <a:off x="3137040" y="1487520"/>
            <a:ext cx="604800" cy="215640"/>
            <a:chOff x="3137040" y="1487520"/>
            <a:chExt cx="604800" cy="215640"/>
          </a:xfrm>
        </p:grpSpPr>
        <p:sp>
          <p:nvSpPr>
            <p:cNvPr id="97" name="TextBox 57"/>
            <p:cNvSpPr/>
            <p:nvPr/>
          </p:nvSpPr>
          <p:spPr>
            <a:xfrm>
              <a:off x="3142440" y="1487520"/>
              <a:ext cx="599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SC5314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Oval 58"/>
            <p:cNvSpPr/>
            <p:nvPr/>
          </p:nvSpPr>
          <p:spPr>
            <a:xfrm>
              <a:off x="3137040" y="1559520"/>
              <a:ext cx="72000" cy="7200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20" bIns="432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99" name="Group 59"/>
          <p:cNvGrpSpPr/>
          <p:nvPr/>
        </p:nvGrpSpPr>
        <p:grpSpPr>
          <a:xfrm>
            <a:off x="3714840" y="1487520"/>
            <a:ext cx="820800" cy="215640"/>
            <a:chOff x="3714840" y="1487520"/>
            <a:chExt cx="820800" cy="215640"/>
          </a:xfrm>
        </p:grpSpPr>
        <p:sp>
          <p:nvSpPr>
            <p:cNvPr id="100" name="TextBox 60"/>
            <p:cNvSpPr/>
            <p:nvPr/>
          </p:nvSpPr>
          <p:spPr>
            <a:xfrm>
              <a:off x="3720240" y="1487520"/>
              <a:ext cx="815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GB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efg1</a:t>
              </a:r>
              <a:r>
                <a:rPr b="0" i="1" lang="el-G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Δ</a:t>
              </a:r>
              <a:r>
                <a:rPr b="0" i="1" lang="en-GB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/cph1</a:t>
              </a:r>
              <a:r>
                <a:rPr b="0" i="1" lang="el-G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Δ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Oval 61"/>
            <p:cNvSpPr/>
            <p:nvPr/>
          </p:nvSpPr>
          <p:spPr>
            <a:xfrm>
              <a:off x="3714840" y="1556280"/>
              <a:ext cx="72000" cy="72000"/>
            </a:xfrm>
            <a:prstGeom prst="ellipse">
              <a:avLst/>
            </a:prstGeom>
            <a:solidFill>
              <a:srgbClr val="bfbfb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20" bIns="432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02" name="Group 62"/>
          <p:cNvGrpSpPr/>
          <p:nvPr/>
        </p:nvGrpSpPr>
        <p:grpSpPr>
          <a:xfrm>
            <a:off x="4508640" y="1487520"/>
            <a:ext cx="501480" cy="215640"/>
            <a:chOff x="4508640" y="1487520"/>
            <a:chExt cx="501480" cy="215640"/>
          </a:xfrm>
        </p:grpSpPr>
        <p:sp>
          <p:nvSpPr>
            <p:cNvPr id="103" name="TextBox 63"/>
            <p:cNvSpPr/>
            <p:nvPr/>
          </p:nvSpPr>
          <p:spPr>
            <a:xfrm>
              <a:off x="4514040" y="1487520"/>
              <a:ext cx="496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GB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nrg1</a:t>
              </a:r>
              <a:r>
                <a:rPr b="0" i="1" lang="el-G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Δ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" name="Oval 64"/>
            <p:cNvSpPr/>
            <p:nvPr/>
          </p:nvSpPr>
          <p:spPr>
            <a:xfrm>
              <a:off x="4508640" y="1559520"/>
              <a:ext cx="72000" cy="7200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20" bIns="432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05" name="TextBox 77"/>
          <p:cNvSpPr/>
          <p:nvPr/>
        </p:nvSpPr>
        <p:spPr>
          <a:xfrm>
            <a:off x="3680640" y="4224240"/>
            <a:ext cx="523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    </a:t>
            </a: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- dox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Rectangle 78"/>
          <p:cNvSpPr/>
          <p:nvPr/>
        </p:nvSpPr>
        <p:spPr>
          <a:xfrm>
            <a:off x="3784680" y="4295880"/>
            <a:ext cx="71280" cy="7128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TextBox 81"/>
          <p:cNvSpPr/>
          <p:nvPr/>
        </p:nvSpPr>
        <p:spPr>
          <a:xfrm>
            <a:off x="3679200" y="4079880"/>
            <a:ext cx="520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    </a:t>
            </a: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+dox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Rectangle 82"/>
          <p:cNvSpPr/>
          <p:nvPr/>
        </p:nvSpPr>
        <p:spPr>
          <a:xfrm>
            <a:off x="3784680" y="4151160"/>
            <a:ext cx="71280" cy="73080"/>
          </a:xfrm>
          <a:prstGeom prst="rect">
            <a:avLst/>
          </a:prstGeom>
          <a:solidFill>
            <a:srgbClr val="595959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5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3-27T10:44:45Z</dcterms:created>
  <dc:creator>Windows User</dc:creator>
  <dc:description/>
  <dc:language>en-US</dc:language>
  <cp:lastModifiedBy>mmd850</cp:lastModifiedBy>
  <dcterms:modified xsi:type="dcterms:W3CDTF">2014-09-16T08:50:49Z</dcterms:modified>
  <cp:revision>176</cp:revision>
  <dc:subject/>
  <dc:title>PowerPoint Presentation</dc:title>
</cp:coreProperties>
</file>